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21D73D-278C-4862-AF66-F3398A66E1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B3A7FB5-64BA-4E85-9665-816DF4A89E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6E89E7-8CF6-49DD-9457-B07E6AF3D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7BDFF7-40B5-4FEB-A18F-5478A108C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E2562A-C45E-4BE7-B50F-3C6D91B43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191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C21BB1-C957-4777-B231-A4A39C3712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604A605-019D-4110-B5D6-F2B29CD646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5D2BC4-E143-45CF-AD10-A8D686823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508D91-A20E-4179-AFAB-6252EA4D3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D17391-ABB7-4F4A-81D0-33122B76F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98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99A7C8B-B09D-4EEA-8987-D73213865A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BA20F07-E842-42CC-8850-B2635E7A25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CE995A-188C-4933-8CBF-D601918A6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53EB55-051D-4AFB-8110-3ECA88492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559093-E7FC-4D15-9137-C46F1D12A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007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509309-BC93-4BF0-B7C2-8C719FDD5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44025DB-6E97-44B6-AA10-EA1D92AFF1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AB58FE-A30F-4721-AAFC-B5C6B3C29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364B2D-66EC-4635-B630-A52583ACD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982D4F-BC72-4236-BABE-3802E4088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990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B07F08-53DF-4185-AFB5-6394F37F0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4B0AB8-0518-4CC1-BF56-4116F851A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C2B248-9CA5-4708-A8B3-6696493B3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ADB251-17D4-404D-AF52-A7F9D2209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A3E055-0469-4B0F-B708-B837B039A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039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9F2263-E8EA-4D32-A735-69EA44D35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2C73AF-408B-4AAD-8ABD-637F58EC7C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703CC6-1CD4-4EDB-B42A-B4A4837BA3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FC8DC2-B592-4F71-BBDF-1F981DA7D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0290E8-1449-4670-9189-610588CFD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5DF58BD-D9C0-4A43-8175-CCA46E7C0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553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89F2E3-0BD7-4C39-8304-47B0A21D6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557ADE-5FA8-4770-849E-D7E319EB9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BAB795-E12C-4797-BB2F-96C8F5B6E5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53C19F-1513-43AC-8295-9FEC2E32FC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E74B2C9-A18B-4F54-881D-AC6B0BFD02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515BD23-A28E-4689-BFE7-D6492EB5F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8B75615-46C2-4A3B-8B3A-98E3774B3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8EAF91D-5F8A-4858-B644-F6DEACDE0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921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488D9F-1E16-43DC-879E-7AC52C56C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D7DC74F-24FA-4D31-B64C-CC8AE7AC1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D388632-0D0C-463B-8FF3-C07D74835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63C92BC-9B3C-49B6-B56C-D18DB71AA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590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AAC6979-8C1F-4615-A97F-A07573D7D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447E6FA-ECEE-4F16-9378-62BF18D6B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FFCBC5F-71BA-4199-B91E-ABF6DDC3B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83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9757C-A4B3-425D-8D18-AA19C8E0B1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81FF5B-29EC-47CB-A1CC-D2B5AF144F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A1CCACF-7386-4C34-823C-68658CCD5D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E99463D-8891-41BA-8D3A-0D3A7EA40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FCCC26-5F50-41B1-954B-74221A33A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A0E139-42F6-4CF4-841B-D7025AFD1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22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DCDDE4-C7FF-46D0-99C1-4D79ECA447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0ED7E85-E3E6-4158-B78C-EFC1B3CC21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38546A7-9F63-4DC3-8563-A89BB14517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EEE31D-A174-4155-B09D-5D5C1D1CB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CECE56-4795-4EA1-80ED-8D14ED87F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C91B74-136F-42EF-8687-EBDA4FE4B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86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48524E4-E12B-4F9C-85AB-546FB7157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561D-A6A0-4B0B-B76A-583FFFFE8B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7328AF-85D2-4C75-8F36-A52CAFE030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EE7CBD-C2A2-46F9-AFDC-D4462AACFCD1}" type="datetimeFigureOut">
              <a:rPr lang="en-US" smtClean="0"/>
              <a:t>10/26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4F3D58-5FED-4A56-A268-343983BE64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E35F4F-E8BB-4301-8C2D-ADA6B46A25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2A80E-E2C7-4F5C-99C9-5F62D7E74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65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EDDB9FF-DDC7-4A5B-9D92-0E2BED054A31}"/>
              </a:ext>
            </a:extLst>
          </p:cNvPr>
          <p:cNvSpPr/>
          <p:nvPr/>
        </p:nvSpPr>
        <p:spPr>
          <a:xfrm>
            <a:off x="4402564" y="705321"/>
            <a:ext cx="4680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verage expression per label (log2 transformed)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3AEA5F7-AA55-4BB9-9B5A-6FF480C695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2019" y="0"/>
            <a:ext cx="1736848" cy="685800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726A5F72-7BE5-4F45-B080-1034E06A394E}"/>
              </a:ext>
            </a:extLst>
          </p:cNvPr>
          <p:cNvSpPr/>
          <p:nvPr/>
        </p:nvSpPr>
        <p:spPr>
          <a:xfrm>
            <a:off x="4402564" y="154905"/>
            <a:ext cx="23748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GTEx</a:t>
            </a:r>
            <a:r>
              <a:rPr lang="en-US" dirty="0"/>
              <a:t> v8 54 tissue types</a:t>
            </a:r>
          </a:p>
        </p:txBody>
      </p:sp>
    </p:spTree>
    <p:extLst>
      <p:ext uri="{BB962C8B-B14F-4D97-AF65-F5344CB8AC3E}">
        <p14:creationId xmlns:p14="http://schemas.microsoft.com/office/powerpoint/2010/main" val="1366243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EDDB9FF-DDC7-4A5B-9D92-0E2BED054A31}"/>
              </a:ext>
            </a:extLst>
          </p:cNvPr>
          <p:cNvSpPr/>
          <p:nvPr/>
        </p:nvSpPr>
        <p:spPr>
          <a:xfrm>
            <a:off x="4047457" y="598789"/>
            <a:ext cx="6852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verage of normalized expression per label (zero mean across samples)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65043BF3-798F-4147-8FA5-BD867B7B346F}"/>
              </a:ext>
            </a:extLst>
          </p:cNvPr>
          <p:cNvSpPr/>
          <p:nvPr/>
        </p:nvSpPr>
        <p:spPr>
          <a:xfrm>
            <a:off x="4047457" y="94527"/>
            <a:ext cx="23748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GTEx</a:t>
            </a:r>
            <a:r>
              <a:rPr lang="en-US" dirty="0"/>
              <a:t> v8 54 tissue types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DB466EF-45B7-4551-932D-F44C4CA871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724" y="0"/>
            <a:ext cx="173684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165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EDDB9FF-DDC7-4A5B-9D92-0E2BED054A31}"/>
              </a:ext>
            </a:extLst>
          </p:cNvPr>
          <p:cNvSpPr/>
          <p:nvPr/>
        </p:nvSpPr>
        <p:spPr>
          <a:xfrm>
            <a:off x="4035665" y="794097"/>
            <a:ext cx="4680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verage expression per label (log2 transformed)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791B3871-B0DF-4B67-97C5-E4D9953784B5}"/>
              </a:ext>
            </a:extLst>
          </p:cNvPr>
          <p:cNvSpPr/>
          <p:nvPr/>
        </p:nvSpPr>
        <p:spPr>
          <a:xfrm>
            <a:off x="4035665" y="66128"/>
            <a:ext cx="31263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GTEx</a:t>
            </a:r>
            <a:r>
              <a:rPr lang="en-US" dirty="0"/>
              <a:t> v8 30 general tissue types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9820B4E-45F2-483D-B857-EF1C802DA1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751" y="66128"/>
            <a:ext cx="109219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813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EDDB9FF-DDC7-4A5B-9D92-0E2BED054A31}"/>
              </a:ext>
            </a:extLst>
          </p:cNvPr>
          <p:cNvSpPr/>
          <p:nvPr/>
        </p:nvSpPr>
        <p:spPr>
          <a:xfrm>
            <a:off x="3991277" y="696443"/>
            <a:ext cx="6852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verage of normalized expression per label (zero mean across samples)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4474DC23-BD7B-464D-AC99-904CBA7F12A3}"/>
              </a:ext>
            </a:extLst>
          </p:cNvPr>
          <p:cNvSpPr/>
          <p:nvPr/>
        </p:nvSpPr>
        <p:spPr>
          <a:xfrm>
            <a:off x="3991277" y="119394"/>
            <a:ext cx="31263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GTEx</a:t>
            </a:r>
            <a:r>
              <a:rPr lang="en-US" dirty="0"/>
              <a:t> v8 30 general tissue types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911744F-C07B-449C-8F59-E10010A44F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735" y="119394"/>
            <a:ext cx="109219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146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2</Words>
  <Application>Microsoft Office PowerPoint</Application>
  <PresentationFormat>宽屏</PresentationFormat>
  <Paragraphs>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wen TAO (20617230)</dc:creator>
  <cp:lastModifiedBy>Yiwen TAO (20617230)</cp:lastModifiedBy>
  <cp:revision>1</cp:revision>
  <dcterms:created xsi:type="dcterms:W3CDTF">2024-10-26T07:31:07Z</dcterms:created>
  <dcterms:modified xsi:type="dcterms:W3CDTF">2024-10-26T07:37:36Z</dcterms:modified>
</cp:coreProperties>
</file>